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4660"/>
  </p:normalViewPr>
  <p:slideViewPr>
    <p:cSldViewPr snapToGrid="0">
      <p:cViewPr>
        <p:scale>
          <a:sx n="121" d="100"/>
          <a:sy n="121" d="100"/>
        </p:scale>
        <p:origin x="144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88E0FC-0590-3DF0-DD8A-A41D43C5C7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8D31C3-6A30-F107-7EAB-D43F9B2E85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8147E4-125A-D297-92B4-EFA060A50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D5F47-1C55-173B-58B6-526A67ECD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6388E7-6E26-0D23-548E-49D3A9AD5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58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58742-90DF-1D56-66ED-595B1F197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C8A8A6-3E6F-0E6F-2309-38127EEBC3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9C643-4682-9B73-40AC-6C1F5E4C3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50BB8A-CDE7-9B7A-B97A-1A2EAD6AC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8C8FE7-64E5-4803-AD9D-B34F28860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585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9CC3D2-2626-4900-8E59-597450851E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BFF325-52EA-F2A9-F662-81BF7ED710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A27057-E58B-113A-1720-3FCFE675B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FB6FA-772B-F026-23A2-633FA9691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89C7B5-0B35-7934-673A-2AD6D66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611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46132-2E06-95CD-819F-35F615C92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1988A3-F4CC-FAE6-15EA-A428494926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0FA0C8-B0D4-972A-9668-5400C4EC6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9A8D13-B66B-D465-04DE-F4502CA8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F32FB5-BF65-A2BD-6031-D70FAAF39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451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6FFDE-B9DC-A0E4-75BA-EBE41898B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2456A9-A6C3-B760-169C-C4551068B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D32EA8-4AB2-6371-93F1-9A4BA555A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46142B-EC9A-8F90-5124-21B0757AA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E9431-A207-1C60-138E-A33772BEC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748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9EACA-37EE-ACB3-5BB7-4D36121F9A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059AFE-4DFE-2F30-7421-3905447644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2E3888-D04D-53B5-21DB-9AE761227B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4195DF-1EE4-C992-B8A7-D611B6938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49424F-671A-8284-03AB-449AEF1E8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7F8673-C21B-8358-8D14-35DE16F08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576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CE445D-CECF-1590-2AEF-4931CAD8BD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4CC4D3-743C-1688-A590-E61E831F5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2FBC78-2870-51B6-C305-B367F5458E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E54689-5A38-3A70-35F8-1EB96D2921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2BDBC0-7599-EE45-932D-17D69FDB81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8F4108-0C0B-CE02-66DE-6A5B388E7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A307C1-600E-3E6B-4759-BC01E4FF2D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F59BA3-3CB8-0F02-612B-2DB04345F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74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CB9578-D963-734C-B7DE-69F742B38E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B9BCCA-0BC7-551E-4751-0DD21A197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6750B2-44A9-18BA-0037-219FA5F94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816407-4146-E2F4-B164-AED81F5968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396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AFAC473-CEE1-57AE-7233-DD8F0ED41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180936-3EB7-D6F0-7957-96BF85844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147FBC-4A51-5D36-C629-0706B6B993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231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E51918-A1A9-EF38-2EB8-55C54170EA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DFD475-670E-62E0-4316-1E2F47DBB3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40D553-93CC-A54D-C2B3-23EC310933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81D4E3-1D8A-9FD0-BB3C-911561220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304FD7-9DEC-6E52-7260-E0F760D4B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229B7B-C0DC-C94D-CCBA-E98B7CA5B1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85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CB527E-50BA-90DB-2BF3-5007195A9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806E2F-E623-EEE3-A583-00B2D0C52D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BDFC18-9C49-A5A8-91E8-04D827B1A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580F04-75C8-ACE3-5D80-C39D6089B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8A36B8-3E3D-FA74-3C39-39DDA2FDE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9FAE98-85D9-C25D-7913-88A23DB2D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903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8E8F1B-2648-612C-4676-1F943EB7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7F29CA-ADFC-E22D-EF24-EB7166CB10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357A42-FF83-753B-00AB-5A11A57340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4A575-CD32-4BFB-A108-9FBBCC31FE0D}" type="datetimeFigureOut">
              <a:rPr lang="en-US" smtClean="0"/>
              <a:t>12/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4C085C-67C3-D728-1D6F-4BB4456387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4F52D5-674D-00C9-3A0C-AFD6A65668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6E3EA-F535-4AF7-8700-B4B82A4C63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618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32">
            <a:extLst>
              <a:ext uri="{FF2B5EF4-FFF2-40B4-BE49-F238E27FC236}">
                <a16:creationId xmlns:a16="http://schemas.microsoft.com/office/drawing/2014/main" id="{23C06E25-6EFD-4E17-ADFC-4102649D3BEC}"/>
              </a:ext>
            </a:extLst>
          </p:cNvPr>
          <p:cNvSpPr/>
          <p:nvPr/>
        </p:nvSpPr>
        <p:spPr>
          <a:xfrm>
            <a:off x="1762295" y="1438797"/>
            <a:ext cx="4223858" cy="11293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54097B03-2B06-FA4B-1253-768C9FDF36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084016" y="977432"/>
            <a:ext cx="2495550" cy="1590675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7631B221-D909-BA59-53FF-83517AEF844A}"/>
              </a:ext>
            </a:extLst>
          </p:cNvPr>
          <p:cNvSpPr txBox="1"/>
          <p:nvPr/>
        </p:nvSpPr>
        <p:spPr>
          <a:xfrm>
            <a:off x="3311546" y="1590295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GLT2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DFA2A2EE-23DE-195C-167B-C24843867EE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flipH="1">
            <a:off x="4048816" y="2917350"/>
            <a:ext cx="2533650" cy="163830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82CD9C11-A48D-ADA4-EA1B-74E16D51A154}"/>
              </a:ext>
            </a:extLst>
          </p:cNvPr>
          <p:cNvSpPr txBox="1"/>
          <p:nvPr/>
        </p:nvSpPr>
        <p:spPr>
          <a:xfrm>
            <a:off x="3226016" y="3727829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797E31D-DE1D-9D5E-F573-B3AE04A57FAD}"/>
              </a:ext>
            </a:extLst>
          </p:cNvPr>
          <p:cNvSpPr/>
          <p:nvPr/>
        </p:nvSpPr>
        <p:spPr>
          <a:xfrm>
            <a:off x="5106856" y="1087180"/>
            <a:ext cx="472383" cy="1362048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E035945-DB27-9026-05FE-2FA7FC9A9585}"/>
              </a:ext>
            </a:extLst>
          </p:cNvPr>
          <p:cNvSpPr/>
          <p:nvPr/>
        </p:nvSpPr>
        <p:spPr>
          <a:xfrm>
            <a:off x="4443828" y="1093937"/>
            <a:ext cx="472383" cy="1362048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9A3D403-740A-A779-992F-0F97486276EF}"/>
              </a:ext>
            </a:extLst>
          </p:cNvPr>
          <p:cNvSpPr/>
          <p:nvPr/>
        </p:nvSpPr>
        <p:spPr>
          <a:xfrm>
            <a:off x="4473791" y="3055476"/>
            <a:ext cx="439540" cy="1362048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ACB9CA8-4871-4352-4148-A0CC49D0DEF8}"/>
              </a:ext>
            </a:extLst>
          </p:cNvPr>
          <p:cNvSpPr/>
          <p:nvPr/>
        </p:nvSpPr>
        <p:spPr>
          <a:xfrm>
            <a:off x="5099412" y="3055476"/>
            <a:ext cx="521746" cy="1362048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itle 1">
            <a:extLst>
              <a:ext uri="{FF2B5EF4-FFF2-40B4-BE49-F238E27FC236}">
                <a16:creationId xmlns:a16="http://schemas.microsoft.com/office/drawing/2014/main" id="{9413B193-AE94-08A8-20CB-8083B55DE0A1}"/>
              </a:ext>
            </a:extLst>
          </p:cNvPr>
          <p:cNvSpPr txBox="1">
            <a:spLocks/>
          </p:cNvSpPr>
          <p:nvPr/>
        </p:nvSpPr>
        <p:spPr>
          <a:xfrm>
            <a:off x="3071468" y="4904893"/>
            <a:ext cx="5099379" cy="115334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Uncropped immunoblots for the data shown in Supplementary Figure 2a. </a:t>
            </a:r>
          </a:p>
        </p:txBody>
      </p:sp>
    </p:spTree>
    <p:extLst>
      <p:ext uri="{BB962C8B-B14F-4D97-AF65-F5344CB8AC3E}">
        <p14:creationId xmlns:p14="http://schemas.microsoft.com/office/powerpoint/2010/main" val="423690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5</TotalTime>
  <Words>16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ila E Gulieva</dc:creator>
  <cp:lastModifiedBy>Benjamin S. Freedman</cp:lastModifiedBy>
  <cp:revision>4</cp:revision>
  <dcterms:created xsi:type="dcterms:W3CDTF">2022-12-02T18:35:55Z</dcterms:created>
  <dcterms:modified xsi:type="dcterms:W3CDTF">2022-12-03T16:49:31Z</dcterms:modified>
</cp:coreProperties>
</file>